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CC94B22-3430-411F-B248-A07EB88534DF}" v="1" dt="2025-11-24T18:42:38.9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7" autoAdjust="0"/>
    <p:restoredTop sz="94660"/>
  </p:normalViewPr>
  <p:slideViewPr>
    <p:cSldViewPr snapToGrid="0">
      <p:cViewPr varScale="1">
        <p:scale>
          <a:sx n="94" d="100"/>
          <a:sy n="94" d="100"/>
        </p:scale>
        <p:origin x="108" y="4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hmed Hassoon" userId="16057bd6-d079-48de-a345-34204837ee93" providerId="ADAL" clId="{822DA664-1BCA-4FEA-B8E4-10E5B781606C}"/>
    <pc:docChg chg="modSld">
      <pc:chgData name="Ahmed Hassoon" userId="16057bd6-d079-48de-a345-34204837ee93" providerId="ADAL" clId="{822DA664-1BCA-4FEA-B8E4-10E5B781606C}" dt="2025-11-24T18:43:11.554" v="70" actId="1076"/>
      <pc:docMkLst>
        <pc:docMk/>
      </pc:docMkLst>
      <pc:sldChg chg="addSp modSp mod">
        <pc:chgData name="Ahmed Hassoon" userId="16057bd6-d079-48de-a345-34204837ee93" providerId="ADAL" clId="{822DA664-1BCA-4FEA-B8E4-10E5B781606C}" dt="2025-11-24T18:43:11.554" v="70" actId="1076"/>
        <pc:sldMkLst>
          <pc:docMk/>
          <pc:sldMk cId="2559356393" sldId="256"/>
        </pc:sldMkLst>
        <pc:spChg chg="add mod">
          <ac:chgData name="Ahmed Hassoon" userId="16057bd6-d079-48de-a345-34204837ee93" providerId="ADAL" clId="{822DA664-1BCA-4FEA-B8E4-10E5B781606C}" dt="2025-11-24T18:43:11.554" v="70" actId="1076"/>
          <ac:spMkLst>
            <pc:docMk/>
            <pc:sldMk cId="2559356393" sldId="256"/>
            <ac:spMk id="2" creationId="{CFFBE64B-14D5-9418-4121-C7466015B99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08A83A-504E-FE38-2890-43B04B286A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B03481-0889-13DF-FF2B-97F05B694F1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5B474E-A441-3973-D386-FB182895C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13877E-B222-1541-2C0E-34A7BF97A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031CBF-1730-42F8-E11A-3276B1A45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0888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322D9-8820-5760-3E4C-BFA75D242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18B9C5-5F93-F513-549F-BB35D5CE43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426EA7-6213-EA99-DE3F-FF7EF7E5A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A85213-1966-2BE7-6E6B-C3181B60D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3D7966-E5B6-6C5A-D34B-6E181398F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918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39597D-9315-DF8E-2323-18EB8D8607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8E8033F-B02C-B01E-AC33-5FF10F0503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88C12D-E48E-0F22-36C0-79462D6E8D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C7C441-A42B-A84B-95A6-3487A6D5B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968077-BDCB-5FED-DBEF-D601743E91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161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286893-8526-A48C-B0D5-78CA253B5F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E3463E-DECB-31F1-DB53-9F6337211D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E0D07E-3E0B-A6EA-C0B2-5654094AF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898DCD-79DC-3D03-CBF2-B88DD5DDD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742B29-1DA7-02D7-C0C0-DC9D920A9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25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3E232-957E-E4D4-90A3-5FC031DFC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0D63B1-8576-4D55-0D1C-8CBA683D2C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74A42B-6356-5E25-028E-575308651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222138-5117-1BB5-55DE-22D4FD3B4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3C9DCD-49C4-67BE-5AEA-6F3E28E99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066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CFB316-DCFB-7E06-97A4-EA99DCD74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26E1CFC-84FF-073E-8018-25F8818D1A2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DF3C4B-AC01-037B-5296-22554D686D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4D9557-19F7-73F3-AEB3-085B982B2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C4116B-7E1C-74C3-5412-EBFFFA4A9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5F27F8-23F1-6597-ED52-5C3ECEEA53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3136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860985-1B6F-0BD1-A84F-4FC7145DA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C853FE-359F-FC71-4EFF-5B941BBA7D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A31BF3-F949-67EC-8F23-96F20CD878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29F92B0-09DD-85BF-0F3F-B450ACAFACC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0CEBE16-BE47-454A-C315-C88E1A48B3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E1BD02-66EC-7096-FDC8-B4D028225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FC12D35-96FD-0509-91D1-8062F888C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D46C68D-5DDC-E105-2778-B9BA0E08BA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677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99221D-A125-8A1B-0696-7BD4877365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7ADF2F-958B-798F-A3C6-7B98E1D6C4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42B78F-4A7D-408A-255E-95E21F6B7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658AF5B-C92A-8B6E-5686-2B405F8DE1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151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F13FC2C-B88E-2349-5353-7230F3A6A1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1FEE23-E3A2-60E3-B02E-1A38CC3A4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866FED9-17DF-4434-49B5-204C18CEE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32149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CD80E1-777B-2376-9953-98086CE773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F3B8B9-93A7-8F07-25CD-B19F7DC4C1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DBA190-46FB-B223-64F3-3174C6E929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00BBF-E83C-0F45-C9AA-E272B2FF6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43C852-B4EB-6BF4-4B6C-DFE3766A5D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9E79A-52D1-C7F0-9C0F-8AA26A91B6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07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FCB22-B850-F619-CDFF-01AF6E296A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C588DA-632E-54B1-C375-1B69CF7124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5499FB-E5DA-55DE-2A7C-B156369A99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06981-2D51-09D6-BC71-63467C5F8C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31D5A0-166B-C905-9FC9-FECE7A841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6D37C4-24DF-9890-F76F-B565AC5FE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65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3D4650-8409-BA22-9E04-7452D43DC5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51B658-784D-1C8C-76CD-AE420C25FB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F67337-4DC7-BA0B-9FF1-09BF391EDB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5024C7-1226-499C-8F81-24CA98B594E9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E6E517-8FCA-966C-FD6F-A105EAF382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C53469-BB9E-E46A-C7DA-3AB50E75F5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081F4D-583A-47DF-AD14-F7CAD69860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46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72590378-9594-CF83-9823-61D0CF5B8068}"/>
              </a:ext>
            </a:extLst>
          </p:cNvPr>
          <p:cNvSpPr/>
          <p:nvPr/>
        </p:nvSpPr>
        <p:spPr>
          <a:xfrm>
            <a:off x="5153025" y="313082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20 misdiagnosed conditions identified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8A3B23D3-5181-3A17-987E-BDE6C7F50010}"/>
              </a:ext>
            </a:extLst>
          </p:cNvPr>
          <p:cNvSpPr/>
          <p:nvPr/>
        </p:nvSpPr>
        <p:spPr>
          <a:xfrm>
            <a:off x="7286625" y="969064"/>
            <a:ext cx="2190750" cy="1050649"/>
          </a:xfrm>
          <a:prstGeom prst="rect">
            <a:avLst/>
          </a:prstGeom>
          <a:solidFill>
            <a:sysClr val="window" lastClr="FFFFFF"/>
          </a:solidFill>
          <a:ln w="190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50 cases from our own research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10 published cases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0 cases generated by our physicians</a:t>
            </a:r>
            <a:endParaRPr lang="en-US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66EDB87-461F-F506-B711-579F1F639D18}"/>
              </a:ext>
            </a:extLst>
          </p:cNvPr>
          <p:cNvSpPr/>
          <p:nvPr/>
        </p:nvSpPr>
        <p:spPr>
          <a:xfrm>
            <a:off x="5153025" y="2294282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200</a:t>
            </a:r>
            <a:r>
              <a:rPr lang="en-US" sz="1000" i="1" kern="100" dirty="0">
                <a:ea typeface="Aptos" panose="020B0004020202020204" pitchFamily="34" charset="0"/>
                <a:cs typeface="Times New Roman" panose="02020603050405020304" pitchFamily="18" charset="0"/>
              </a:rPr>
              <a:t> Origin </a:t>
            </a: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Cases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76945B71-F882-0D3F-8145-899A6E720931}"/>
              </a:ext>
            </a:extLst>
          </p:cNvPr>
          <p:cNvCxnSpPr>
            <a:stCxn id="4" idx="2"/>
            <a:endCxn id="6" idx="0"/>
          </p:cNvCxnSpPr>
          <p:nvPr/>
        </p:nvCxnSpPr>
        <p:spPr>
          <a:xfrm>
            <a:off x="6096000" y="770282"/>
            <a:ext cx="0" cy="152400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1B009609-8CD0-7625-05A0-B633ECEC1AB9}"/>
              </a:ext>
            </a:extLst>
          </p:cNvPr>
          <p:cNvCxnSpPr>
            <a:stCxn id="5" idx="1"/>
          </p:cNvCxnSpPr>
          <p:nvPr/>
        </p:nvCxnSpPr>
        <p:spPr>
          <a:xfrm flipH="1" flipV="1">
            <a:off x="6096000" y="1494388"/>
            <a:ext cx="1190625" cy="1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Rectangle 10">
            <a:extLst>
              <a:ext uri="{FF2B5EF4-FFF2-40B4-BE49-F238E27FC236}">
                <a16:creationId xmlns:a16="http://schemas.microsoft.com/office/drawing/2014/main" id="{BBB2F1E5-A752-A96B-028B-6540B7B1999F}"/>
              </a:ext>
            </a:extLst>
          </p:cNvPr>
          <p:cNvSpPr/>
          <p:nvPr/>
        </p:nvSpPr>
        <p:spPr>
          <a:xfrm>
            <a:off x="2743859" y="2294282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200 case with no diagnosis for de novo testing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0A3DE772-7C13-5F27-A334-D071B3D59579}"/>
              </a:ext>
            </a:extLst>
          </p:cNvPr>
          <p:cNvSpPr/>
          <p:nvPr/>
        </p:nvSpPr>
        <p:spPr>
          <a:xfrm>
            <a:off x="4079246" y="3467474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800 case variant by race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27448A50-564F-9D42-31B3-876B9A513EE1}"/>
              </a:ext>
            </a:extLst>
          </p:cNvPr>
          <p:cNvSpPr/>
          <p:nvPr/>
        </p:nvSpPr>
        <p:spPr>
          <a:xfrm>
            <a:off x="1931688" y="3467474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400 case variant by provider’s characteristics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B2E0B007-F74F-6707-1976-142CDE46B8F9}"/>
              </a:ext>
            </a:extLst>
          </p:cNvPr>
          <p:cNvSpPr/>
          <p:nvPr/>
        </p:nvSpPr>
        <p:spPr>
          <a:xfrm>
            <a:off x="6226804" y="3467474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400 case variant by insurance type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0A4BD66-4DA6-A2CB-C681-52C6823A9A69}"/>
              </a:ext>
            </a:extLst>
          </p:cNvPr>
          <p:cNvSpPr/>
          <p:nvPr/>
        </p:nvSpPr>
        <p:spPr>
          <a:xfrm>
            <a:off x="8374362" y="3467474"/>
            <a:ext cx="1885950" cy="4572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400 case variant by hospital reputation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3495206D-B09D-25A6-8FB0-814179E5C7BF}"/>
              </a:ext>
            </a:extLst>
          </p:cNvPr>
          <p:cNvCxnSpPr>
            <a:stCxn id="6" idx="1"/>
            <a:endCxn id="11" idx="3"/>
          </p:cNvCxnSpPr>
          <p:nvPr/>
        </p:nvCxnSpPr>
        <p:spPr>
          <a:xfrm flipH="1">
            <a:off x="4629809" y="2522882"/>
            <a:ext cx="523216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449A371-9B4D-F73E-600D-ADC5ACC42B39}"/>
              </a:ext>
            </a:extLst>
          </p:cNvPr>
          <p:cNvCxnSpPr>
            <a:stCxn id="6" idx="2"/>
            <a:endCxn id="13" idx="0"/>
          </p:cNvCxnSpPr>
          <p:nvPr/>
        </p:nvCxnSpPr>
        <p:spPr>
          <a:xfrm flipH="1">
            <a:off x="2874663" y="2751482"/>
            <a:ext cx="3221337" cy="7159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0B315D34-170D-3FAF-56D9-A93B873F5E74}"/>
              </a:ext>
            </a:extLst>
          </p:cNvPr>
          <p:cNvCxnSpPr>
            <a:stCxn id="6" idx="2"/>
            <a:endCxn id="12" idx="0"/>
          </p:cNvCxnSpPr>
          <p:nvPr/>
        </p:nvCxnSpPr>
        <p:spPr>
          <a:xfrm flipH="1">
            <a:off x="5022221" y="2751482"/>
            <a:ext cx="1073779" cy="7159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D878687C-8957-C6D8-6E54-BAAC87EE322D}"/>
              </a:ext>
            </a:extLst>
          </p:cNvPr>
          <p:cNvCxnSpPr>
            <a:stCxn id="6" idx="2"/>
            <a:endCxn id="14" idx="0"/>
          </p:cNvCxnSpPr>
          <p:nvPr/>
        </p:nvCxnSpPr>
        <p:spPr>
          <a:xfrm>
            <a:off x="6096000" y="2751482"/>
            <a:ext cx="1073779" cy="7159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8E5AEB9D-D786-5E1E-2CE2-5B9DE0ADAC48}"/>
              </a:ext>
            </a:extLst>
          </p:cNvPr>
          <p:cNvCxnSpPr>
            <a:stCxn id="6" idx="2"/>
            <a:endCxn id="15" idx="0"/>
          </p:cNvCxnSpPr>
          <p:nvPr/>
        </p:nvCxnSpPr>
        <p:spPr>
          <a:xfrm>
            <a:off x="6096000" y="2751482"/>
            <a:ext cx="3221337" cy="715992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6" name="Rectangle 25">
            <a:extLst>
              <a:ext uri="{FF2B5EF4-FFF2-40B4-BE49-F238E27FC236}">
                <a16:creationId xmlns:a16="http://schemas.microsoft.com/office/drawing/2014/main" id="{FEF2728B-98D5-B160-75F8-0B020F95417B}"/>
              </a:ext>
            </a:extLst>
          </p:cNvPr>
          <p:cNvSpPr/>
          <p:nvPr/>
        </p:nvSpPr>
        <p:spPr>
          <a:xfrm>
            <a:off x="5153025" y="4640665"/>
            <a:ext cx="1885950" cy="71599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ffectLst/>
                <a:ea typeface="Aptos" panose="020B0004020202020204" pitchFamily="34" charset="0"/>
                <a:cs typeface="Times New Roman" panose="02020603050405020304" pitchFamily="18" charset="0"/>
              </a:rPr>
              <a:t>2200 total cases</a:t>
            </a:r>
          </a:p>
          <a:p>
            <a:pPr marL="0" marR="0" algn="ctr"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Including</a:t>
            </a:r>
            <a:r>
              <a:rPr lang="en-US" sz="1000" i="1" kern="100" dirty="0">
                <a:ea typeface="Aptos" panose="020B0004020202020204" pitchFamily="34" charset="0"/>
                <a:cs typeface="Times New Roman" panose="02020603050405020304" pitchFamily="18" charset="0"/>
              </a:rPr>
              <a:t> Origin </a:t>
            </a:r>
            <a:r>
              <a:rPr lang="en-US" sz="1000" kern="100" dirty="0">
                <a:ea typeface="Aptos" panose="020B0004020202020204" pitchFamily="34" charset="0"/>
                <a:cs typeface="Times New Roman" panose="02020603050405020304" pitchFamily="18" charset="0"/>
              </a:rPr>
              <a:t>cases and all it’s variants</a:t>
            </a:r>
            <a:endParaRPr lang="en-US" sz="1200" kern="100" dirty="0">
              <a:effectLst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5B4F8991-2277-CC67-477A-04F3CD34FC17}"/>
              </a:ext>
            </a:extLst>
          </p:cNvPr>
          <p:cNvCxnSpPr>
            <a:stCxn id="13" idx="2"/>
            <a:endCxn id="26" idx="0"/>
          </p:cNvCxnSpPr>
          <p:nvPr/>
        </p:nvCxnSpPr>
        <p:spPr>
          <a:xfrm>
            <a:off x="2874663" y="3924674"/>
            <a:ext cx="3221337" cy="7159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E0FBEAC-8AE9-2A18-11AB-E8E5741B40A0}"/>
              </a:ext>
            </a:extLst>
          </p:cNvPr>
          <p:cNvCxnSpPr>
            <a:stCxn id="12" idx="2"/>
            <a:endCxn id="26" idx="0"/>
          </p:cNvCxnSpPr>
          <p:nvPr/>
        </p:nvCxnSpPr>
        <p:spPr>
          <a:xfrm>
            <a:off x="5022221" y="3924674"/>
            <a:ext cx="1073779" cy="7159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7F934E20-A1C9-24BF-3E9A-70E6AD8EA9D2}"/>
              </a:ext>
            </a:extLst>
          </p:cNvPr>
          <p:cNvCxnSpPr>
            <a:stCxn id="14" idx="2"/>
            <a:endCxn id="26" idx="0"/>
          </p:cNvCxnSpPr>
          <p:nvPr/>
        </p:nvCxnSpPr>
        <p:spPr>
          <a:xfrm flipH="1">
            <a:off x="6096000" y="3924674"/>
            <a:ext cx="1073779" cy="7159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9D968529-30B7-C75C-A3F4-899DAF445D67}"/>
              </a:ext>
            </a:extLst>
          </p:cNvPr>
          <p:cNvCxnSpPr>
            <a:stCxn id="15" idx="2"/>
            <a:endCxn id="26" idx="0"/>
          </p:cNvCxnSpPr>
          <p:nvPr/>
        </p:nvCxnSpPr>
        <p:spPr>
          <a:xfrm flipH="1">
            <a:off x="6096000" y="3924674"/>
            <a:ext cx="3221337" cy="715991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5370E248-3B37-8501-582F-FADB4E93FF0C}"/>
              </a:ext>
            </a:extLst>
          </p:cNvPr>
          <p:cNvCxnSpPr>
            <a:stCxn id="6" idx="2"/>
            <a:endCxn id="26" idx="0"/>
          </p:cNvCxnSpPr>
          <p:nvPr/>
        </p:nvCxnSpPr>
        <p:spPr>
          <a:xfrm>
            <a:off x="6096000" y="2751482"/>
            <a:ext cx="0" cy="1889183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CFFBE64B-14D5-9418-4121-C7466015B990}"/>
              </a:ext>
            </a:extLst>
          </p:cNvPr>
          <p:cNvSpPr txBox="1"/>
          <p:nvPr/>
        </p:nvSpPr>
        <p:spPr>
          <a:xfrm>
            <a:off x="375920" y="313082"/>
            <a:ext cx="5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upplemental Figure 1: Cases generation diagram</a:t>
            </a:r>
          </a:p>
        </p:txBody>
      </p:sp>
    </p:spTree>
    <p:extLst>
      <p:ext uri="{BB962C8B-B14F-4D97-AF65-F5344CB8AC3E}">
        <p14:creationId xmlns:p14="http://schemas.microsoft.com/office/powerpoint/2010/main" val="2559356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71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hmed Hassoon</dc:creator>
  <cp:lastModifiedBy>Ahmed Hassoon</cp:lastModifiedBy>
  <cp:revision>1</cp:revision>
  <dcterms:created xsi:type="dcterms:W3CDTF">2025-11-10T19:55:28Z</dcterms:created>
  <dcterms:modified xsi:type="dcterms:W3CDTF">2025-11-24T18:43:13Z</dcterms:modified>
</cp:coreProperties>
</file>